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D97D3-B1C6-42AA-843B-AE0ACF9A60AA}" type="datetimeFigureOut">
              <a:rPr lang="de-DE" smtClean="0"/>
              <a:t>26.06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10B94-166B-4619-8926-6E530DB4C5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9980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D97D3-B1C6-42AA-843B-AE0ACF9A60AA}" type="datetimeFigureOut">
              <a:rPr lang="de-DE" smtClean="0"/>
              <a:t>26.06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10B94-166B-4619-8926-6E530DB4C5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73871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D97D3-B1C6-42AA-843B-AE0ACF9A60AA}" type="datetimeFigureOut">
              <a:rPr lang="de-DE" smtClean="0"/>
              <a:t>26.06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10B94-166B-4619-8926-6E530DB4C5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2561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D97D3-B1C6-42AA-843B-AE0ACF9A60AA}" type="datetimeFigureOut">
              <a:rPr lang="de-DE" smtClean="0"/>
              <a:t>26.06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10B94-166B-4619-8926-6E530DB4C5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5400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D97D3-B1C6-42AA-843B-AE0ACF9A60AA}" type="datetimeFigureOut">
              <a:rPr lang="de-DE" smtClean="0"/>
              <a:t>26.06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10B94-166B-4619-8926-6E530DB4C5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2775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D97D3-B1C6-42AA-843B-AE0ACF9A60AA}" type="datetimeFigureOut">
              <a:rPr lang="de-DE" smtClean="0"/>
              <a:t>26.06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10B94-166B-4619-8926-6E530DB4C5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9218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D97D3-B1C6-42AA-843B-AE0ACF9A60AA}" type="datetimeFigureOut">
              <a:rPr lang="de-DE" smtClean="0"/>
              <a:t>26.06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10B94-166B-4619-8926-6E530DB4C5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03577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D97D3-B1C6-42AA-843B-AE0ACF9A60AA}" type="datetimeFigureOut">
              <a:rPr lang="de-DE" smtClean="0"/>
              <a:t>26.06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10B94-166B-4619-8926-6E530DB4C5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5113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D97D3-B1C6-42AA-843B-AE0ACF9A60AA}" type="datetimeFigureOut">
              <a:rPr lang="de-DE" smtClean="0"/>
              <a:t>26.06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10B94-166B-4619-8926-6E530DB4C5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9956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D97D3-B1C6-42AA-843B-AE0ACF9A60AA}" type="datetimeFigureOut">
              <a:rPr lang="de-DE" smtClean="0"/>
              <a:t>26.06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10B94-166B-4619-8926-6E530DB4C5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9664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D97D3-B1C6-42AA-843B-AE0ACF9A60AA}" type="datetimeFigureOut">
              <a:rPr lang="de-DE" smtClean="0"/>
              <a:t>26.06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C10B94-166B-4619-8926-6E530DB4C5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7647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FD97D3-B1C6-42AA-843B-AE0ACF9A60AA}" type="datetimeFigureOut">
              <a:rPr lang="de-DE" smtClean="0"/>
              <a:t>26.06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C10B94-166B-4619-8926-6E530DB4C5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9019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06490" y="631273"/>
            <a:ext cx="5243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file 1</a:t>
            </a:r>
            <a:r>
              <a:rPr lang="en-US" sz="1100" dirty="0"/>
              <a:t> Primers used for </a:t>
            </a:r>
            <a:r>
              <a:rPr lang="en-US" sz="1100" i="1" dirty="0" err="1"/>
              <a:t>polE</a:t>
            </a:r>
            <a:r>
              <a:rPr lang="en-US" sz="1100" dirty="0"/>
              <a:t> gene deletion in </a:t>
            </a:r>
            <a:r>
              <a:rPr lang="en-US" sz="1100" i="1" dirty="0"/>
              <a:t>K. baliensis </a:t>
            </a:r>
            <a:r>
              <a:rPr lang="en-US" sz="1100" dirty="0"/>
              <a:t>NBRC16680 R </a:t>
            </a:r>
            <a:endParaRPr lang="de-DE" sz="1100" dirty="0"/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1853437"/>
              </p:ext>
            </p:extLst>
          </p:nvPr>
        </p:nvGraphicFramePr>
        <p:xfrm>
          <a:off x="721178" y="1560376"/>
          <a:ext cx="6438900" cy="3090358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166100"/>
                <a:gridCol w="2573025"/>
                <a:gridCol w="1419600"/>
                <a:gridCol w="1280175"/>
              </a:tblGrid>
              <a:tr h="3054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</a:rPr>
                        <a:t>Primer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</a:rPr>
                        <a:t>Sequence (5`-&gt; 3`)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primer location </a:t>
                      </a:r>
                      <a:endParaRPr lang="de-DE" sz="110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NBRC16680 genome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Product size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054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G4F_Fw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ACGACGCGCATGAGTAAACC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900" kern="1200">
                          <a:effectLst/>
                        </a:rPr>
                        <a:t>1.471.189 – 1.471.208 bp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25209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TE_Rv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CAACCCGTGATTTGAACTCC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mobile element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5209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P1_polE_KpnI_Fw 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AAGCTGGTACCGCACTTTACCGAAGCGAAGGGATG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2.545.632 – 2.545.666 bp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25209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P2_polE_Rv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u="sng" kern="1200">
                          <a:effectLst/>
                        </a:rPr>
                        <a:t>CATCCGGGCGGAAGCCGCC</a:t>
                      </a:r>
                      <a:r>
                        <a:rPr lang="en-US" sz="900" kern="1200">
                          <a:effectLst/>
                        </a:rPr>
                        <a:t>TTTCGCGTGGAAGATCTG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2.546.552 – 2.546.570 bp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effectLst/>
                        </a:rPr>
                        <a:t>957 </a:t>
                      </a:r>
                      <a:r>
                        <a:rPr lang="en-US" sz="900" kern="1200" dirty="0" err="1">
                          <a:effectLst/>
                        </a:rPr>
                        <a:t>bp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5209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P3_polE_Fw 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u="sng" kern="1200">
                          <a:effectLst/>
                        </a:rPr>
                        <a:t>CAGATCTTCCACGCGAAA</a:t>
                      </a:r>
                      <a:r>
                        <a:rPr lang="en-US" sz="900" kern="1200">
                          <a:effectLst/>
                        </a:rPr>
                        <a:t>GGCGGCTTCCGCCCGGATG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2.547.627 – 2.547.645 bp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25209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P4_polE_XbaI_Rv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CGATCTAGACTCCAAAGGCGAGCCGGTTTATAATG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2.548.552 – 2.548.586 bp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</a:rPr>
                        <a:t>968 </a:t>
                      </a:r>
                      <a:r>
                        <a:rPr lang="en-US" sz="900" kern="1200" dirty="0" err="1">
                          <a:solidFill>
                            <a:schemeClr val="tx1"/>
                          </a:solidFill>
                          <a:effectLst/>
                        </a:rPr>
                        <a:t>bp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5209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pK18MCS-Fw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TTCCGGCTCGTATGTTGTG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pKOS6b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25209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pK18MCS-Rv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CAGCTGGCAATTCCGGTTC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pKOS6b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5209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CL_polE_Fw 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TGCCCGCATCTGAACATCGC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2.545.569 – 2.545.588 bp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25209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CL_polE_Rv 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CGAGCCGGTTTATAATGACG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effectLst/>
                        </a:rPr>
                        <a:t>2.548.549 – 2.548.568 bp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71817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</Words>
  <Application>Microsoft Office PowerPoint</Application>
  <PresentationFormat>Breitbild</PresentationFormat>
  <Paragraphs>3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ank</dc:creator>
  <cp:lastModifiedBy>Frank</cp:lastModifiedBy>
  <cp:revision>3</cp:revision>
  <dcterms:created xsi:type="dcterms:W3CDTF">2017-04-20T14:15:59Z</dcterms:created>
  <dcterms:modified xsi:type="dcterms:W3CDTF">2017-06-26T09:56:29Z</dcterms:modified>
</cp:coreProperties>
</file>